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7C25A9-6D38-44F5-9573-7287101084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14F7C0-A88B-4A30-858A-C3E8A5796B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5C5D0D-F80F-4DAE-850F-D36B60CAB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52FB4-6251-4F6C-822C-6B0311F8B1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79F99-E5E6-480B-8D9E-5A4F856C3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2671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EF7C7-32E3-4199-A16B-8E3441E074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40608B-C182-4FE4-989C-566A3B91E3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01EE7B-FD6C-4270-B6FC-80A41A6C1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A8905E-FDDE-4A1D-A950-5042C5D84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F95DB0-B4C1-45C6-B0DA-4553EE2D0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885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BC147D-64EB-40F0-8C25-0446B70A22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6A5D3FB-D4F8-414C-9184-2342868B3F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E8FCE7-F69C-4C96-A03D-BB19B5638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B5A1F8-BF6E-4854-AA99-741AD0982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5F70E4-EF76-4EF9-84FF-9C48A1EF8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58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7B83C-64E5-4A6C-88BC-F60A4A58C2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D87ED7-C6EF-4170-A2FA-BA008994B6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066FD2-878F-4720-B293-B164CC7EE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4B9FF4-A742-441E-8B6C-C3110E2599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92DFCF-8716-4B68-A909-9C5EBAF9F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230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3BFAC8-1F84-4945-BEDA-80952311A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384FED-F16C-4F80-8698-5BAD45575C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A6055B-7663-456A-8355-2956450C1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2A6F5F-415C-421F-A333-E05FC5AAB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597189-2C64-4114-98FC-9D3C67875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997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312DA6-C9F3-4AC4-A7F0-4AA8C98BC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0ABDED-2C08-47BB-BC91-D4BCDB78B2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265F77-2D06-46DF-B04C-1156BDC5E1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DD9B8E-88C4-4E11-915E-AB589D9A1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185907-F0C0-438C-B631-CF35728D4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6966F5-70C5-4FFC-B736-E5450F3A76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473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5F326-07C5-4480-8C4C-7FA071246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191A91-957A-4F9A-8AF8-4F2FAD351D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D600CE-3AF8-4E18-8EEC-51FDBF9C3E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D292F3C-0B8C-431B-B72D-E7046DDDA7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6EFBF4-BF13-45E8-9EC2-B67B273C23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C049361-3A8D-4CC0-8C58-FEAB431AD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1ED178E-5024-443B-A95B-5B515A8C3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913E1DB-DD40-476D-B5DA-809ADBC50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95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E372F6-A559-4E4D-B4FE-95333E474C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3D72DF-EF9D-4CC4-B028-C276929C0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6F6FB7-B4C8-4A81-8EA0-0E0702D6B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C84C7F-B025-4929-9CEB-8B178DE1D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9594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407493C-8C84-4822-A0E5-602CBDFD8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7AD149-566B-4CD1-A0ED-9B60FCA11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85F023-47FC-407B-A3CC-2E070189E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196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0F3FE-8854-4314-95CE-B9B78B7248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476D40-B022-401A-858D-72AE16A62F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E0F9D3-F8D0-497D-91EA-544C1304F6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1080B-5144-4C40-9F57-CFD7BF1E1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5FB9E1-867B-4E71-B8C6-4E4B7DF4E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A21D116-AF93-4402-B0C0-CFD13C122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610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4BD236-864D-437F-9FB2-156D3B3255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F8B6201-D243-4CCE-B01E-9E544B42BC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4AB65E-40B0-4AD5-81E5-BC048C45E8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836435-F530-4BCD-8F81-110A5B29A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47EB16-11DB-4390-9AE6-A8DE1EBF8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5925F4-F256-4A9C-8FA6-B188012B0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590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45FFE3-A2F4-4A11-8916-0473977BAE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66B57F-9A96-4492-9904-D2987DCE9E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1BE9A7-D153-4924-9D0F-DF1289977F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E5C36-7D96-4485-877C-2E84E347375D}" type="datetimeFigureOut">
              <a:rPr lang="en-US" smtClean="0"/>
              <a:t>11/1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F8B59-07E2-4621-ACA3-54ADF31E4C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7C086-186E-4AE3-9B52-EBD6E9443F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11251-DA0F-425E-9AC6-D49C299B1B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86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9.tiff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8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tiff"/><Relationship Id="rId5" Type="http://schemas.openxmlformats.org/officeDocument/2006/relationships/image" Target="../media/image3.png"/><Relationship Id="rId10" Type="http://schemas.openxmlformats.org/officeDocument/2006/relationships/image" Target="../media/image6.tiff"/><Relationship Id="rId4" Type="http://schemas.microsoft.com/office/2007/relationships/hdphoto" Target="../media/hdphoto1.wdp"/><Relationship Id="rId9" Type="http://schemas.openxmlformats.org/officeDocument/2006/relationships/image" Target="../media/image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>
            <a:extLst>
              <a:ext uri="{FF2B5EF4-FFF2-40B4-BE49-F238E27FC236}">
                <a16:creationId xmlns:a16="http://schemas.microsoft.com/office/drawing/2014/main" id="{674F0273-3054-4AE3-9E2C-C8664FE454FA}"/>
              </a:ext>
            </a:extLst>
          </p:cNvPr>
          <p:cNvSpPr txBox="1"/>
          <p:nvPr/>
        </p:nvSpPr>
        <p:spPr>
          <a:xfrm>
            <a:off x="9584267" y="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4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78CDDB90-4BA6-486B-8190-50627EF81386}"/>
              </a:ext>
            </a:extLst>
          </p:cNvPr>
          <p:cNvSpPr/>
          <p:nvPr/>
        </p:nvSpPr>
        <p:spPr>
          <a:xfrm>
            <a:off x="76199" y="5736759"/>
            <a:ext cx="11853334" cy="7591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300"/>
              </a:lnSpc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upplementary </a:t>
            </a:r>
            <a:r>
              <a:rPr lang="en-US" sz="1200" b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ure S4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S sensitizes MM cells to BTZ.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RPMI8226  cells were incubated with 10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of GS and 5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M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of BTZ alone or in combination for 24 h.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bar graph displays the cell viability determined by CCK-8 analysis. Data is presented as mean ± SD (n=6.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***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 </a:t>
            </a:r>
            <a:r>
              <a:rPr lang="en-US" sz="120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&lt; 0.001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. 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GS and BTZ- treated cells were lysed, and protein expression of  Casapas-3 ,cleaved caspase-3. cleaved caspase-8,  and GAPDH was determined.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 Cell viability using a live/dead cytotoxicity kit was also assessed (Scale bar, 200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). </a:t>
            </a:r>
            <a:endParaRPr lang="en-US" sz="1200" dirty="0">
              <a:solidFill>
                <a:srgbClr val="000000"/>
              </a:solidFill>
              <a:effectLst/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EA787DE5-7619-4FF7-B05F-FF1D974A6F2E}"/>
              </a:ext>
            </a:extLst>
          </p:cNvPr>
          <p:cNvGrpSpPr/>
          <p:nvPr/>
        </p:nvGrpSpPr>
        <p:grpSpPr>
          <a:xfrm>
            <a:off x="409612" y="289561"/>
            <a:ext cx="10455055" cy="4992163"/>
            <a:chOff x="409612" y="289561"/>
            <a:chExt cx="10455055" cy="499216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EC3593AB-C239-4F6B-80B1-F48CE613464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1713" y="289561"/>
              <a:ext cx="3973513" cy="2958782"/>
            </a:xfrm>
            <a:prstGeom prst="rect">
              <a:avLst/>
            </a:prstGeom>
          </p:spPr>
        </p:pic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8E1FB50-6B4F-4E94-977D-F9CB64FF235D}"/>
                </a:ext>
              </a:extLst>
            </p:cNvPr>
            <p:cNvGrpSpPr/>
            <p:nvPr/>
          </p:nvGrpSpPr>
          <p:grpSpPr>
            <a:xfrm>
              <a:off x="1922209" y="3501595"/>
              <a:ext cx="7000468" cy="1759915"/>
              <a:chOff x="603199" y="4528623"/>
              <a:chExt cx="7000468" cy="1759915"/>
            </a:xfrm>
          </p:grpSpPr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C55D7E8D-CD73-4B60-897E-8BE02050318D}"/>
                  </a:ext>
                </a:extLst>
              </p:cNvPr>
              <p:cNvGrpSpPr/>
              <p:nvPr/>
            </p:nvGrpSpPr>
            <p:grpSpPr>
              <a:xfrm>
                <a:off x="1693333" y="4995798"/>
                <a:ext cx="5910333" cy="1292740"/>
                <a:chOff x="5273359" y="3729249"/>
                <a:chExt cx="5479656" cy="1030700"/>
              </a:xfrm>
            </p:grpSpPr>
            <p:pic>
              <p:nvPicPr>
                <p:cNvPr id="8" name="Picture 7" descr="Background pattern&#10;&#10;Description automatically generated">
                  <a:extLst>
                    <a:ext uri="{FF2B5EF4-FFF2-40B4-BE49-F238E27FC236}">
                      <a16:creationId xmlns:a16="http://schemas.microsoft.com/office/drawing/2014/main" id="{021AB40E-388C-42CF-9373-447DFBCBC7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636417" y="3729249"/>
                  <a:ext cx="1345882" cy="1024686"/>
                </a:xfrm>
                <a:prstGeom prst="rect">
                  <a:avLst/>
                </a:prstGeom>
              </p:spPr>
            </p:pic>
            <p:pic>
              <p:nvPicPr>
                <p:cNvPr id="9" name="Picture 8" descr="Background pattern&#10;&#10;Description automatically generated">
                  <a:extLst>
                    <a:ext uri="{FF2B5EF4-FFF2-40B4-BE49-F238E27FC236}">
                      <a16:creationId xmlns:a16="http://schemas.microsoft.com/office/drawing/2014/main" id="{F7ECEB15-1580-403B-B71E-55B13C2009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012402" y="3735263"/>
                  <a:ext cx="1344700" cy="1024686"/>
                </a:xfrm>
                <a:prstGeom prst="rect">
                  <a:avLst/>
                </a:prstGeom>
              </p:spPr>
            </p:pic>
            <p:pic>
              <p:nvPicPr>
                <p:cNvPr id="10" name="Picture 9" descr="Background pattern&#10;&#10;Description automatically generated">
                  <a:extLst>
                    <a:ext uri="{FF2B5EF4-FFF2-40B4-BE49-F238E27FC236}">
                      <a16:creationId xmlns:a16="http://schemas.microsoft.com/office/drawing/2014/main" id="{96E3DA78-8D50-4DB7-8F99-55049B69E5B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394728" y="3735599"/>
                  <a:ext cx="1358287" cy="1024349"/>
                </a:xfrm>
                <a:prstGeom prst="rect">
                  <a:avLst/>
                </a:prstGeom>
              </p:spPr>
            </p:pic>
            <p:pic>
              <p:nvPicPr>
                <p:cNvPr id="11" name="Picture 10" descr="A picture containing light&#10;&#10;Description automatically generated">
                  <a:extLst>
                    <a:ext uri="{FF2B5EF4-FFF2-40B4-BE49-F238E27FC236}">
                      <a16:creationId xmlns:a16="http://schemas.microsoft.com/office/drawing/2014/main" id="{4D549816-8F51-4559-8588-49C040720A6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273359" y="3735263"/>
                  <a:ext cx="1337657" cy="1012657"/>
                </a:xfrm>
                <a:prstGeom prst="rect">
                  <a:avLst/>
                </a:prstGeom>
              </p:spPr>
            </p:pic>
          </p:grp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2DECA295-3906-44BD-8F31-3E5E00283135}"/>
                  </a:ext>
                </a:extLst>
              </p:cNvPr>
              <p:cNvSpPr txBox="1"/>
              <p:nvPr/>
            </p:nvSpPr>
            <p:spPr>
              <a:xfrm>
                <a:off x="603199" y="4528623"/>
                <a:ext cx="700046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S 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10μM)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 -                                    +                                     -                                    +</a:t>
                </a:r>
              </a:p>
              <a:p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TZ 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5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M</a:t>
                </a: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         -                                     -                                     +                                   +</a:t>
                </a:r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51FD117-9FC7-4651-A5A0-F43F39B2A6D6}"/>
                </a:ext>
              </a:extLst>
            </p:cNvPr>
            <p:cNvGrpSpPr/>
            <p:nvPr/>
          </p:nvGrpSpPr>
          <p:grpSpPr>
            <a:xfrm>
              <a:off x="7626776" y="463483"/>
              <a:ext cx="3237891" cy="2392930"/>
              <a:chOff x="7626776" y="463483"/>
              <a:chExt cx="3237891" cy="2392930"/>
            </a:xfrm>
          </p:grpSpPr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D2EA4B5-9ECB-43CD-B51B-87948159495F}"/>
                  </a:ext>
                </a:extLst>
              </p:cNvPr>
              <p:cNvSpPr txBox="1"/>
              <p:nvPr/>
            </p:nvSpPr>
            <p:spPr>
              <a:xfrm>
                <a:off x="7626776" y="463483"/>
                <a:ext cx="3071182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S 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10μM)</a:t>
                </a: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-           +          -           +</a:t>
                </a:r>
              </a:p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TZ 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5nM</a:t>
                </a:r>
                <a:r>
                  <a:rPr lang="en-US" sz="1200" b="1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       -            -          +          +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D7C43D3A-2B9E-47D0-A3D1-24B41F703796}"/>
                  </a:ext>
                </a:extLst>
              </p:cNvPr>
              <p:cNvSpPr txBox="1"/>
              <p:nvPr/>
            </p:nvSpPr>
            <p:spPr>
              <a:xfrm>
                <a:off x="8627495" y="2058550"/>
                <a:ext cx="22371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ot: anti-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caspase-8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0F143360-3F1A-419E-AB02-F2822B811DC8}"/>
                  </a:ext>
                </a:extLst>
              </p:cNvPr>
              <p:cNvSpPr txBox="1"/>
              <p:nvPr/>
            </p:nvSpPr>
            <p:spPr>
              <a:xfrm>
                <a:off x="8922677" y="2579414"/>
                <a:ext cx="164680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   Blot: anti-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7CF83ED-F219-451A-94CF-4362E4054F1D}"/>
                  </a:ext>
                </a:extLst>
              </p:cNvPr>
              <p:cNvSpPr txBox="1"/>
              <p:nvPr/>
            </p:nvSpPr>
            <p:spPr>
              <a:xfrm>
                <a:off x="8627495" y="1567607"/>
                <a:ext cx="22371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ot: anti-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 caspase-3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4" name="Picture 23">
                <a:extLst>
                  <a:ext uri="{FF2B5EF4-FFF2-40B4-BE49-F238E27FC236}">
                    <a16:creationId xmlns:a16="http://schemas.microsoft.com/office/drawing/2014/main" id="{7F6375CA-CE98-4456-8E6F-19C1CEAF605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895" t="45312" r="49046" b="46164"/>
              <a:stretch/>
            </p:blipFill>
            <p:spPr>
              <a:xfrm>
                <a:off x="8733531" y="917172"/>
                <a:ext cx="1956821" cy="231322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C93821D2-C5CB-4302-B437-73FA7D0FFC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59" t="65342" r="48727" b="24003"/>
              <a:stretch/>
            </p:blipFill>
            <p:spPr>
              <a:xfrm>
                <a:off x="8733531" y="1352790"/>
                <a:ext cx="1949164" cy="272142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id="{B76119C1-23A4-422A-9620-4DB642A7A47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112" t="35309" r="50612" b="54765"/>
              <a:stretch/>
            </p:blipFill>
            <p:spPr>
              <a:xfrm>
                <a:off x="8733531" y="1840350"/>
                <a:ext cx="1949164" cy="263639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id="{38929D75-6867-42C9-ACFB-BBD423A86E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034" t="35510" r="43952" b="56393"/>
              <a:stretch/>
            </p:blipFill>
            <p:spPr>
              <a:xfrm>
                <a:off x="8741188" y="2335549"/>
                <a:ext cx="1949164" cy="246235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F05B392-A109-4DB5-8644-742E57F5A586}"/>
                  </a:ext>
                </a:extLst>
              </p:cNvPr>
              <p:cNvSpPr txBox="1"/>
              <p:nvPr/>
            </p:nvSpPr>
            <p:spPr>
              <a:xfrm>
                <a:off x="8794770" y="1092358"/>
                <a:ext cx="188523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lot: anti-</a:t>
                </a:r>
                <a:r>
                  <a:rPr lang="en-GB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leaved-3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2C3CAF7-4ABD-469B-A92E-7954196857B9}"/>
                </a:ext>
              </a:extLst>
            </p:cNvPr>
            <p:cNvSpPr txBox="1"/>
            <p:nvPr/>
          </p:nvSpPr>
          <p:spPr>
            <a:xfrm>
              <a:off x="8048328" y="5069740"/>
              <a:ext cx="4228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lang="en-US" sz="600" dirty="0" err="1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μm</a:t>
              </a:r>
              <a:endParaRPr lang="en-GB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9A4A9AE-1E1F-40DB-88A5-DFECFF966045}"/>
                </a:ext>
              </a:extLst>
            </p:cNvPr>
            <p:cNvSpPr txBox="1"/>
            <p:nvPr/>
          </p:nvSpPr>
          <p:spPr>
            <a:xfrm>
              <a:off x="5141511" y="5069740"/>
              <a:ext cx="4228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lang="en-US" sz="600" dirty="0" err="1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μm</a:t>
              </a:r>
              <a:endParaRPr lang="en-GB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B274B94-19D2-4FA5-8184-424D325A8A27}"/>
                </a:ext>
              </a:extLst>
            </p:cNvPr>
            <p:cNvSpPr txBox="1"/>
            <p:nvPr/>
          </p:nvSpPr>
          <p:spPr>
            <a:xfrm>
              <a:off x="3665376" y="5043697"/>
              <a:ext cx="4228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lang="en-US" sz="600" dirty="0" err="1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μm</a:t>
              </a:r>
              <a:endParaRPr lang="en-GB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A43B011-8A0E-441E-8E64-C3FE6FB364FF}"/>
                </a:ext>
              </a:extLst>
            </p:cNvPr>
            <p:cNvSpPr txBox="1"/>
            <p:nvPr/>
          </p:nvSpPr>
          <p:spPr>
            <a:xfrm>
              <a:off x="6583286" y="5097058"/>
              <a:ext cx="4228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lang="en-US" sz="600" dirty="0" err="1">
                  <a:solidFill>
                    <a:schemeClr val="bg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μm</a:t>
              </a:r>
              <a:endParaRPr lang="en-GB" sz="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A804EFEE-BAAE-4494-92FA-B4B38B105EC1}"/>
                </a:ext>
              </a:extLst>
            </p:cNvPr>
            <p:cNvSpPr txBox="1"/>
            <p:nvPr/>
          </p:nvSpPr>
          <p:spPr>
            <a:xfrm>
              <a:off x="409612" y="509649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 Black" panose="020B0A04020102020204" pitchFamily="34" charset="0"/>
                </a:rPr>
                <a:t>A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947FD48-4440-47B1-87EC-FEF50FB475A0}"/>
                </a:ext>
              </a:extLst>
            </p:cNvPr>
            <p:cNvSpPr txBox="1"/>
            <p:nvPr/>
          </p:nvSpPr>
          <p:spPr>
            <a:xfrm>
              <a:off x="7088640" y="371241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 Black" panose="020B0A04020102020204" pitchFamily="34" charset="0"/>
                </a:rPr>
                <a:t>B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CD22D002-814A-4B8B-A4E7-9EDF19D8E77F}"/>
                </a:ext>
              </a:extLst>
            </p:cNvPr>
            <p:cNvSpPr txBox="1"/>
            <p:nvPr/>
          </p:nvSpPr>
          <p:spPr>
            <a:xfrm>
              <a:off x="1306801" y="3606017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 Black" panose="020B0A040201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01775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18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Arial Black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ab Uddin Khan</dc:creator>
  <cp:lastModifiedBy>MDPI</cp:lastModifiedBy>
  <cp:revision>7</cp:revision>
  <dcterms:created xsi:type="dcterms:W3CDTF">2022-10-31T14:50:24Z</dcterms:created>
  <dcterms:modified xsi:type="dcterms:W3CDTF">2022-11-18T07:08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2-10-31T14:50:25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c2f22f48-fce0-4a18-ab5e-ac4ea55b86a8</vt:lpwstr>
  </property>
  <property fmtid="{D5CDD505-2E9C-101B-9397-08002B2CF9AE}" pid="8" name="MSIP_Label_573f5887-035d-4765-8d10-97aaac8deb4a_ContentBits">
    <vt:lpwstr>0</vt:lpwstr>
  </property>
</Properties>
</file>